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6400800" cy="8229600"/>
  <p:notesSz cx="6858000" cy="9144000"/>
  <p:defaultTextStyle>
    <a:defPPr>
      <a:defRPr lang="en-US"/>
    </a:defPPr>
    <a:lvl1pPr marL="0" algn="l" defTabSz="39899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1pPr>
    <a:lvl2pPr marL="398998" algn="l" defTabSz="39899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2pPr>
    <a:lvl3pPr marL="797997" algn="l" defTabSz="39899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3pPr>
    <a:lvl4pPr marL="1196995" algn="l" defTabSz="39899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4pPr>
    <a:lvl5pPr marL="1595994" algn="l" defTabSz="39899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5pPr>
    <a:lvl6pPr marL="1994992" algn="l" defTabSz="39899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6pPr>
    <a:lvl7pPr marL="2393991" algn="l" defTabSz="39899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7pPr>
    <a:lvl8pPr marL="2792989" algn="l" defTabSz="39899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8pPr>
    <a:lvl9pPr marL="3191988" algn="l" defTabSz="398998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36">
          <p15:clr>
            <a:srgbClr val="A4A3A4"/>
          </p15:clr>
        </p15:guide>
        <p15:guide id="2" pos="203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6"/>
    <p:restoredTop sz="94663"/>
  </p:normalViewPr>
  <p:slideViewPr>
    <p:cSldViewPr snapToGrid="0" snapToObjects="1">
      <p:cViewPr varScale="1">
        <p:scale>
          <a:sx n="97" d="100"/>
          <a:sy n="97" d="100"/>
        </p:scale>
        <p:origin x="2784" y="216"/>
      </p:cViewPr>
      <p:guideLst>
        <p:guide orient="horz" pos="2336"/>
        <p:guide pos="203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4" Type="http://schemas.openxmlformats.org/officeDocument/2006/relationships/image" Target="../media/image4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3964D3-74B6-3A41-9219-42BEE685A2CC}" type="datetimeFigureOut">
              <a:rPr lang="en-US" smtClean="0"/>
              <a:t>6/23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95500" y="685800"/>
            <a:ext cx="2667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468B47-FF50-2B40-8B80-19A75F36E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16173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98998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1pPr>
    <a:lvl2pPr marL="398998" algn="l" defTabSz="398998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2pPr>
    <a:lvl3pPr marL="797997" algn="l" defTabSz="398998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3pPr>
    <a:lvl4pPr marL="1196995" algn="l" defTabSz="398998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4pPr>
    <a:lvl5pPr marL="1595994" algn="l" defTabSz="398998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5pPr>
    <a:lvl6pPr marL="1994992" algn="l" defTabSz="398998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6pPr>
    <a:lvl7pPr marL="2393991" algn="l" defTabSz="398998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7pPr>
    <a:lvl8pPr marL="2792989" algn="l" defTabSz="398998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8pPr>
    <a:lvl9pPr marL="3191988" algn="l" defTabSz="398998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095500" y="685800"/>
            <a:ext cx="2667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.</a:t>
            </a:r>
            <a:r>
              <a:rPr lang="en-US" baseline="0" dirty="0"/>
              <a:t> 4ZO1 Staining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2ECA5B-BB3F-4CF6-BE5C-0A8C66A7236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3963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2556511"/>
            <a:ext cx="5440680" cy="176403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60120" y="4663440"/>
            <a:ext cx="4480560" cy="21031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989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979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969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5959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9949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3939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7929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1919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0991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063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480435" y="476250"/>
            <a:ext cx="1080135" cy="1014222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40031" y="476250"/>
            <a:ext cx="3133725" cy="1014222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828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8987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5619" y="5288281"/>
            <a:ext cx="5440680" cy="1634490"/>
          </a:xfrm>
        </p:spPr>
        <p:txBody>
          <a:bodyPr anchor="t"/>
          <a:lstStyle>
            <a:lvl1pPr algn="l">
              <a:defRPr sz="35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5619" y="3488056"/>
            <a:ext cx="5440680" cy="1800225"/>
          </a:xfrm>
        </p:spPr>
        <p:txBody>
          <a:bodyPr anchor="b"/>
          <a:lstStyle>
            <a:lvl1pPr marL="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1pPr>
            <a:lvl2pPr marL="39899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9799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19699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59599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99499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39399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79298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319198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7684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40030" y="2773681"/>
            <a:ext cx="2106930" cy="784479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7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53640" y="2773681"/>
            <a:ext cx="2106930" cy="784479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7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8006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329565"/>
            <a:ext cx="5760720" cy="13716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842135"/>
            <a:ext cx="2828132" cy="767715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398998" indent="0">
              <a:buNone/>
              <a:defRPr sz="1700" b="1"/>
            </a:lvl2pPr>
            <a:lvl3pPr marL="797997" indent="0">
              <a:buNone/>
              <a:defRPr sz="1600" b="1"/>
            </a:lvl3pPr>
            <a:lvl4pPr marL="1196995" indent="0">
              <a:buNone/>
              <a:defRPr sz="1400" b="1"/>
            </a:lvl4pPr>
            <a:lvl5pPr marL="1595994" indent="0">
              <a:buNone/>
              <a:defRPr sz="1400" b="1"/>
            </a:lvl5pPr>
            <a:lvl6pPr marL="1994992" indent="0">
              <a:buNone/>
              <a:defRPr sz="1400" b="1"/>
            </a:lvl6pPr>
            <a:lvl7pPr marL="2393991" indent="0">
              <a:buNone/>
              <a:defRPr sz="1400" b="1"/>
            </a:lvl7pPr>
            <a:lvl8pPr marL="2792989" indent="0">
              <a:buNone/>
              <a:defRPr sz="1400" b="1"/>
            </a:lvl8pPr>
            <a:lvl9pPr marL="3191988" indent="0">
              <a:buNone/>
              <a:defRPr sz="1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0040" y="2609850"/>
            <a:ext cx="2828132" cy="4741546"/>
          </a:xfrm>
        </p:spPr>
        <p:txBody>
          <a:bodyPr/>
          <a:lstStyle>
            <a:lvl1pPr>
              <a:defRPr sz="2100"/>
            </a:lvl1pPr>
            <a:lvl2pPr>
              <a:defRPr sz="17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51518" y="1842135"/>
            <a:ext cx="2829242" cy="767715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398998" indent="0">
              <a:buNone/>
              <a:defRPr sz="1700" b="1"/>
            </a:lvl2pPr>
            <a:lvl3pPr marL="797997" indent="0">
              <a:buNone/>
              <a:defRPr sz="1600" b="1"/>
            </a:lvl3pPr>
            <a:lvl4pPr marL="1196995" indent="0">
              <a:buNone/>
              <a:defRPr sz="1400" b="1"/>
            </a:lvl4pPr>
            <a:lvl5pPr marL="1595994" indent="0">
              <a:buNone/>
              <a:defRPr sz="1400" b="1"/>
            </a:lvl5pPr>
            <a:lvl6pPr marL="1994992" indent="0">
              <a:buNone/>
              <a:defRPr sz="1400" b="1"/>
            </a:lvl6pPr>
            <a:lvl7pPr marL="2393991" indent="0">
              <a:buNone/>
              <a:defRPr sz="1400" b="1"/>
            </a:lvl7pPr>
            <a:lvl8pPr marL="2792989" indent="0">
              <a:buNone/>
              <a:defRPr sz="1400" b="1"/>
            </a:lvl8pPr>
            <a:lvl9pPr marL="3191988" indent="0">
              <a:buNone/>
              <a:defRPr sz="1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51518" y="2609850"/>
            <a:ext cx="2829242" cy="4741546"/>
          </a:xfrm>
        </p:spPr>
        <p:txBody>
          <a:bodyPr/>
          <a:lstStyle>
            <a:lvl1pPr>
              <a:defRPr sz="2100"/>
            </a:lvl1pPr>
            <a:lvl2pPr>
              <a:defRPr sz="17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300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0100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5046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1" y="327660"/>
            <a:ext cx="2105819" cy="1394460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02535" y="327661"/>
            <a:ext cx="3578225" cy="702373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0041" y="1722120"/>
            <a:ext cx="2105819" cy="5629276"/>
          </a:xfrm>
        </p:spPr>
        <p:txBody>
          <a:bodyPr/>
          <a:lstStyle>
            <a:lvl1pPr marL="0" indent="0">
              <a:buNone/>
              <a:defRPr sz="1200"/>
            </a:lvl1pPr>
            <a:lvl2pPr marL="398998" indent="0">
              <a:buNone/>
              <a:defRPr sz="1000"/>
            </a:lvl2pPr>
            <a:lvl3pPr marL="797997" indent="0">
              <a:buNone/>
              <a:defRPr sz="900"/>
            </a:lvl3pPr>
            <a:lvl4pPr marL="1196995" indent="0">
              <a:buNone/>
              <a:defRPr sz="800"/>
            </a:lvl4pPr>
            <a:lvl5pPr marL="1595994" indent="0">
              <a:buNone/>
              <a:defRPr sz="800"/>
            </a:lvl5pPr>
            <a:lvl6pPr marL="1994992" indent="0">
              <a:buNone/>
              <a:defRPr sz="800"/>
            </a:lvl6pPr>
            <a:lvl7pPr marL="2393991" indent="0">
              <a:buNone/>
              <a:defRPr sz="800"/>
            </a:lvl7pPr>
            <a:lvl8pPr marL="2792989" indent="0">
              <a:buNone/>
              <a:defRPr sz="800"/>
            </a:lvl8pPr>
            <a:lvl9pPr marL="3191988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1942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4602" y="5760720"/>
            <a:ext cx="3840480" cy="680086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54602" y="735330"/>
            <a:ext cx="3840480" cy="4937760"/>
          </a:xfrm>
        </p:spPr>
        <p:txBody>
          <a:bodyPr/>
          <a:lstStyle>
            <a:lvl1pPr marL="0" indent="0">
              <a:buNone/>
              <a:defRPr sz="2800"/>
            </a:lvl1pPr>
            <a:lvl2pPr marL="398998" indent="0">
              <a:buNone/>
              <a:defRPr sz="2400"/>
            </a:lvl2pPr>
            <a:lvl3pPr marL="797997" indent="0">
              <a:buNone/>
              <a:defRPr sz="2100"/>
            </a:lvl3pPr>
            <a:lvl4pPr marL="1196995" indent="0">
              <a:buNone/>
              <a:defRPr sz="1700"/>
            </a:lvl4pPr>
            <a:lvl5pPr marL="1595994" indent="0">
              <a:buNone/>
              <a:defRPr sz="1700"/>
            </a:lvl5pPr>
            <a:lvl6pPr marL="1994992" indent="0">
              <a:buNone/>
              <a:defRPr sz="1700"/>
            </a:lvl6pPr>
            <a:lvl7pPr marL="2393991" indent="0">
              <a:buNone/>
              <a:defRPr sz="1700"/>
            </a:lvl7pPr>
            <a:lvl8pPr marL="2792989" indent="0">
              <a:buNone/>
              <a:defRPr sz="1700"/>
            </a:lvl8pPr>
            <a:lvl9pPr marL="3191988" indent="0">
              <a:buNone/>
              <a:defRPr sz="17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4602" y="6440806"/>
            <a:ext cx="3840480" cy="965834"/>
          </a:xfrm>
        </p:spPr>
        <p:txBody>
          <a:bodyPr/>
          <a:lstStyle>
            <a:lvl1pPr marL="0" indent="0">
              <a:buNone/>
              <a:defRPr sz="1200"/>
            </a:lvl1pPr>
            <a:lvl2pPr marL="398998" indent="0">
              <a:buNone/>
              <a:defRPr sz="1000"/>
            </a:lvl2pPr>
            <a:lvl3pPr marL="797997" indent="0">
              <a:buNone/>
              <a:defRPr sz="900"/>
            </a:lvl3pPr>
            <a:lvl4pPr marL="1196995" indent="0">
              <a:buNone/>
              <a:defRPr sz="800"/>
            </a:lvl4pPr>
            <a:lvl5pPr marL="1595994" indent="0">
              <a:buNone/>
              <a:defRPr sz="800"/>
            </a:lvl5pPr>
            <a:lvl6pPr marL="1994992" indent="0">
              <a:buNone/>
              <a:defRPr sz="800"/>
            </a:lvl6pPr>
            <a:lvl7pPr marL="2393991" indent="0">
              <a:buNone/>
              <a:defRPr sz="800"/>
            </a:lvl7pPr>
            <a:lvl8pPr marL="2792989" indent="0">
              <a:buNone/>
              <a:defRPr sz="800"/>
            </a:lvl8pPr>
            <a:lvl9pPr marL="3191988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292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0040" y="329565"/>
            <a:ext cx="5760720" cy="1371600"/>
          </a:xfrm>
          <a:prstGeom prst="rect">
            <a:avLst/>
          </a:prstGeom>
        </p:spPr>
        <p:txBody>
          <a:bodyPr vert="horz" lIns="79800" tIns="39900" rIns="79800" bIns="3990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920241"/>
            <a:ext cx="5760720" cy="5431156"/>
          </a:xfrm>
          <a:prstGeom prst="rect">
            <a:avLst/>
          </a:prstGeom>
        </p:spPr>
        <p:txBody>
          <a:bodyPr vert="horz" lIns="79800" tIns="39900" rIns="79800" bIns="3990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0040" y="7627621"/>
            <a:ext cx="1493520" cy="438150"/>
          </a:xfrm>
          <a:prstGeom prst="rect">
            <a:avLst/>
          </a:prstGeom>
        </p:spPr>
        <p:txBody>
          <a:bodyPr vert="horz" lIns="79800" tIns="39900" rIns="79800" bIns="39900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E8E051-5C71-E64E-8A3F-F881B345A531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86940" y="7627621"/>
            <a:ext cx="2026920" cy="438150"/>
          </a:xfrm>
          <a:prstGeom prst="rect">
            <a:avLst/>
          </a:prstGeom>
        </p:spPr>
        <p:txBody>
          <a:bodyPr vert="horz" lIns="79800" tIns="39900" rIns="79800" bIns="39900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7240" y="7627621"/>
            <a:ext cx="1493520" cy="438150"/>
          </a:xfrm>
          <a:prstGeom prst="rect">
            <a:avLst/>
          </a:prstGeom>
        </p:spPr>
        <p:txBody>
          <a:bodyPr vert="horz" lIns="79800" tIns="39900" rIns="79800" bIns="39900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30445D-4367-0E46-A6D3-1DFA59207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1348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98998" rtl="0" eaLnBrk="1" latinLnBrk="0" hangingPunct="1">
        <a:spcBef>
          <a:spcPct val="0"/>
        </a:spcBef>
        <a:buNone/>
        <a:defRPr sz="3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249" indent="-299249" algn="l" defTabSz="398998" rtl="0" eaLnBrk="1" latinLnBrk="0" hangingPunct="1">
        <a:spcBef>
          <a:spcPct val="20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48372" indent="-249374" algn="l" defTabSz="398998" rtl="0" eaLnBrk="1" latinLnBrk="0" hangingPunct="1">
        <a:spcBef>
          <a:spcPct val="20000"/>
        </a:spcBef>
        <a:buFont typeface="Arial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997496" indent="-199499" algn="l" defTabSz="398998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396495" indent="-199499" algn="l" defTabSz="398998" rtl="0" eaLnBrk="1" latinLnBrk="0" hangingPunct="1">
        <a:spcBef>
          <a:spcPct val="20000"/>
        </a:spcBef>
        <a:buFont typeface="Arial"/>
        <a:buChar char="–"/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795493" indent="-199499" algn="l" defTabSz="398998" rtl="0" eaLnBrk="1" latinLnBrk="0" hangingPunct="1">
        <a:spcBef>
          <a:spcPct val="20000"/>
        </a:spcBef>
        <a:buFont typeface="Arial"/>
        <a:buChar char="»"/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194491" indent="-199499" algn="l" defTabSz="398998" rtl="0" eaLnBrk="1" latinLnBrk="0" hangingPunct="1">
        <a:spcBef>
          <a:spcPct val="20000"/>
        </a:spcBef>
        <a:buFont typeface="Arial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93490" indent="-199499" algn="l" defTabSz="398998" rtl="0" eaLnBrk="1" latinLnBrk="0" hangingPunct="1">
        <a:spcBef>
          <a:spcPct val="20000"/>
        </a:spcBef>
        <a:buFont typeface="Arial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2992488" indent="-199499" algn="l" defTabSz="398998" rtl="0" eaLnBrk="1" latinLnBrk="0" hangingPunct="1">
        <a:spcBef>
          <a:spcPct val="20000"/>
        </a:spcBef>
        <a:buFont typeface="Arial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391487" indent="-199499" algn="l" defTabSz="398998" rtl="0" eaLnBrk="1" latinLnBrk="0" hangingPunct="1">
        <a:spcBef>
          <a:spcPct val="20000"/>
        </a:spcBef>
        <a:buFont typeface="Arial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9899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398998" algn="l" defTabSz="39899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797997" algn="l" defTabSz="39899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196995" algn="l" defTabSz="39899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595994" algn="l" defTabSz="39899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1994992" algn="l" defTabSz="39899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393991" algn="l" defTabSz="39899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792989" algn="l" defTabSz="39899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191988" algn="l" defTabSz="398998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6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wmf"/><Relationship Id="rId12" Type="http://schemas.openxmlformats.org/officeDocument/2006/relationships/image" Target="../media/image5.ti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wmf"/><Relationship Id="rId5" Type="http://schemas.openxmlformats.org/officeDocument/2006/relationships/image" Target="../media/image1.w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261245" y="178614"/>
            <a:ext cx="1981620" cy="234468"/>
          </a:xfrm>
          <a:prstGeom prst="rect">
            <a:avLst/>
          </a:prstGeom>
          <a:noFill/>
        </p:spPr>
        <p:txBody>
          <a:bodyPr wrap="square" lIns="79800" tIns="39900" rIns="79800" bIns="39900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manized mouse Small Intestine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96858" y="174999"/>
            <a:ext cx="550841" cy="234468"/>
          </a:xfrm>
          <a:prstGeom prst="rect">
            <a:avLst/>
          </a:prstGeom>
          <a:noFill/>
        </p:spPr>
        <p:txBody>
          <a:bodyPr wrap="square" lIns="79800" tIns="39900" rIns="79800" bIns="39900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4" name="TextBox 23"/>
          <p:cNvSpPr txBox="1"/>
          <p:nvPr/>
        </p:nvSpPr>
        <p:spPr>
          <a:xfrm rot="16200000">
            <a:off x="-284334" y="902313"/>
            <a:ext cx="981611" cy="234468"/>
          </a:xfrm>
          <a:prstGeom prst="rect">
            <a:avLst/>
          </a:prstGeom>
          <a:noFill/>
        </p:spPr>
        <p:txBody>
          <a:bodyPr wrap="square" lIns="79800" tIns="39900" rIns="79800" bIns="39900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075370" y="413992"/>
            <a:ext cx="711200" cy="234468"/>
          </a:xfrm>
          <a:prstGeom prst="rect">
            <a:avLst/>
          </a:prstGeom>
          <a:noFill/>
        </p:spPr>
        <p:txBody>
          <a:bodyPr wrap="square" lIns="79800" tIns="39900" rIns="79800" bIns="39900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V</a:t>
            </a:r>
          </a:p>
        </p:txBody>
      </p:sp>
      <p:sp>
        <p:nvSpPr>
          <p:cNvPr id="26" name="TextBox 25"/>
          <p:cNvSpPr txBox="1"/>
          <p:nvPr/>
        </p:nvSpPr>
        <p:spPr>
          <a:xfrm rot="16200000">
            <a:off x="-276712" y="2405244"/>
            <a:ext cx="981611" cy="234468"/>
          </a:xfrm>
          <a:prstGeom prst="rect">
            <a:avLst/>
          </a:prstGeom>
          <a:noFill/>
        </p:spPr>
        <p:txBody>
          <a:bodyPr wrap="square" lIns="79800" tIns="39900" rIns="79800" bIns="39900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phine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011230" y="385031"/>
            <a:ext cx="888966" cy="234468"/>
          </a:xfrm>
          <a:prstGeom prst="rect">
            <a:avLst/>
          </a:prstGeom>
          <a:noFill/>
        </p:spPr>
        <p:txBody>
          <a:bodyPr wrap="square" lIns="79800" tIns="39900" rIns="79800" bIns="39900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</p:txBody>
      </p:sp>
      <p:graphicFrame>
        <p:nvGraphicFramePr>
          <p:cNvPr id="29" name="Object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5408267"/>
              </p:ext>
            </p:extLst>
          </p:nvPr>
        </p:nvGraphicFramePr>
        <p:xfrm>
          <a:off x="328603" y="648460"/>
          <a:ext cx="1914493" cy="12801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1" name="Image" r:id="rId4" imgW="5206320" imgH="3911040" progId="Photoshop.Image.11">
                  <p:embed/>
                </p:oleObj>
              </mc:Choice>
              <mc:Fallback>
                <p:oleObj name="Image" r:id="rId4" imgW="5206320" imgH="3911040" progId="Photoshop.Image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28603" y="648460"/>
                        <a:ext cx="1914493" cy="12801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92247528"/>
              </p:ext>
            </p:extLst>
          </p:nvPr>
        </p:nvGraphicFramePr>
        <p:xfrm>
          <a:off x="2308588" y="648460"/>
          <a:ext cx="1914493" cy="12801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2" name="Image" r:id="rId6" imgW="5206320" imgH="3911040" progId="Photoshop.Image.11">
                  <p:embed/>
                </p:oleObj>
              </mc:Choice>
              <mc:Fallback>
                <p:oleObj name="Image" r:id="rId6" imgW="5206320" imgH="3911040" progId="Photoshop.Image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308588" y="648460"/>
                        <a:ext cx="1914493" cy="12801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ct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0427299"/>
              </p:ext>
            </p:extLst>
          </p:nvPr>
        </p:nvGraphicFramePr>
        <p:xfrm>
          <a:off x="328603" y="2031672"/>
          <a:ext cx="1926199" cy="12801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3" name="Image" r:id="rId8" imgW="5218920" imgH="3898080" progId="Photoshop.Image.11">
                  <p:embed/>
                </p:oleObj>
              </mc:Choice>
              <mc:Fallback>
                <p:oleObj name="Image" r:id="rId8" imgW="5218920" imgH="3898080" progId="Photoshop.Image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28603" y="2031672"/>
                        <a:ext cx="1926199" cy="12801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ct 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53445252"/>
              </p:ext>
            </p:extLst>
          </p:nvPr>
        </p:nvGraphicFramePr>
        <p:xfrm>
          <a:off x="2321288" y="2031672"/>
          <a:ext cx="1926199" cy="12801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4" name="Image" r:id="rId10" imgW="5218920" imgH="3898080" progId="Photoshop.Image.11">
                  <p:embed/>
                </p:oleObj>
              </mc:Choice>
              <mc:Fallback>
                <p:oleObj name="Image" r:id="rId10" imgW="5218920" imgH="3898080" progId="Photoshop.Image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321288" y="2031672"/>
                        <a:ext cx="1926199" cy="12801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TextBox 38"/>
          <p:cNvSpPr txBox="1"/>
          <p:nvPr/>
        </p:nvSpPr>
        <p:spPr>
          <a:xfrm flipH="1">
            <a:off x="4268095" y="174999"/>
            <a:ext cx="3105150" cy="234468"/>
          </a:xfrm>
          <a:prstGeom prst="rect">
            <a:avLst/>
          </a:prstGeom>
          <a:noFill/>
        </p:spPr>
        <p:txBody>
          <a:bodyPr wrap="square" lIns="79800" tIns="39900" rIns="79800" bIns="39900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pic>
        <p:nvPicPr>
          <p:cNvPr id="15" name="Picture 14" descr="Experiment_ms ZO-1-1.tif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3807357" y="3291822"/>
            <a:ext cx="0" cy="0"/>
          </a:xfrm>
          <a:prstGeom prst="rect">
            <a:avLst/>
          </a:prstGeom>
        </p:spPr>
      </p:pic>
      <p:pic>
        <p:nvPicPr>
          <p:cNvPr id="28" name="Picture 27" descr="1 - Data 2.pdf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3495" y="732505"/>
            <a:ext cx="2109057" cy="1708096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106340" y="3681511"/>
            <a:ext cx="606586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Supplementary Figure </a:t>
            </a:r>
            <a:r>
              <a:rPr lang="en-US" altLang="zh-CN" sz="1200" b="1" dirty="0">
                <a:latin typeface="Times New Roman"/>
                <a:cs typeface="Times New Roman"/>
              </a:rPr>
              <a:t>2</a:t>
            </a:r>
            <a:r>
              <a:rPr lang="en-US" sz="1200" b="1" dirty="0">
                <a:latin typeface="Times New Roman"/>
                <a:cs typeface="Times New Roman"/>
              </a:rPr>
              <a:t>.</a:t>
            </a:r>
            <a:r>
              <a:rPr lang="en-US" sz="1200" dirty="0">
                <a:latin typeface="Times New Roman"/>
                <a:cs typeface="Times New Roman"/>
              </a:rPr>
              <a:t> (A) Small Intestinal sections harvested from BLT mice infected with vehicle or HIV and treated with or without morphine were stained with anti-ZO-1 antibody. (B) ZO-1 (green) expression levels were quantified by measuring the intensity of green fluorescence within each villus. Quantification from 2 different fields for each animal is depicted. 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51518" y="3369107"/>
            <a:ext cx="1914318" cy="261604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en: ZO-1; Blue: DAPI</a:t>
            </a:r>
          </a:p>
        </p:txBody>
      </p:sp>
    </p:spTree>
    <p:extLst>
      <p:ext uri="{BB962C8B-B14F-4D97-AF65-F5344CB8AC3E}">
        <p14:creationId xmlns:p14="http://schemas.microsoft.com/office/powerpoint/2010/main" val="32394937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9</TotalTime>
  <Words>87</Words>
  <Application>Microsoft Macintosh PowerPoint</Application>
  <PresentationFormat>Custom</PresentationFormat>
  <Paragraphs>11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Image</vt:lpstr>
      <vt:lpstr>PowerPoint Presentation</vt:lpstr>
    </vt:vector>
  </TitlesOfParts>
  <Company>1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ngjing Meng</dc:creator>
  <cp:lastModifiedBy>Meng, Jingjing</cp:lastModifiedBy>
  <cp:revision>18</cp:revision>
  <dcterms:created xsi:type="dcterms:W3CDTF">2017-04-27T20:16:21Z</dcterms:created>
  <dcterms:modified xsi:type="dcterms:W3CDTF">2019-06-23T15:47:34Z</dcterms:modified>
</cp:coreProperties>
</file>